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8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yan, Edward T.,M.D." initials="RET" lastIdx="7" clrIdx="0">
    <p:extLst>
      <p:ext uri="{19B8F6BF-5375-455C-9EA6-DF929625EA0E}">
        <p15:presenceInfo xmlns:p15="http://schemas.microsoft.com/office/powerpoint/2012/main" userId="S-1-5-21-8915387-943144406-1916815836-252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BA502-F328-4E76-801F-02EE2307F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3D972F-0D2B-4935-98AB-182526A4D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79538-F869-4B72-B3D2-EDFBD3030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A7040-C4FB-4E3B-87CE-0C5A17DC6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E004D-7F83-4670-85EB-4CC6CE156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239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978F4-695F-4F7B-A082-6C4769B67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104D9D-0A81-41F1-A212-860FA7783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51CC2-55BE-4339-B9B5-CBF940CA1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31E5F-4383-4978-9B22-C3B0BBA6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2B9E2-2D75-4C44-87B3-B69393CD8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67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E2FAB-F728-46F2-A2EB-F32DE030E6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258111-6159-41C3-B79E-0056033B2D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ED1FE-0774-4E7C-B3F3-2169054F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3F27A-C69E-4A4D-A99E-E3655FC2B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665A6-B42C-435E-8CDE-BEF778073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65138-CB44-451D-A817-366801FC8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251FC-CF00-4887-92A4-EED5243A00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AA48-E76C-430B-B64A-B3CCD5B2C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D58D1-CCFE-4C30-9918-42D9085D5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9FA19-6B85-4913-A2F7-B7ED1A37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4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4EFA8-A4D3-4931-8FE6-DAAC8DCDD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A7BAAD-0FB3-4291-8651-7880D4861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B4443-9B10-4BAC-8048-918581CC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89B3A-FCA0-4EBA-B12D-B5F9A5DD9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4B35DB-67D2-4B5B-A41A-FD33FB63B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00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6D88E-F710-488A-9860-7D9C093F4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7EAEFA-C2F3-472A-B60C-DAE796455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F468C-612D-476D-9FAE-BFC8B9A74D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09373-BF63-4541-A42A-9BB188CFF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8B675-A572-4A23-867F-FB0B4DF7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0CBE6-7D4C-42DC-B5F7-F00A3157D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1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2CBBD-EBBD-43C4-8E93-D4077A6C7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11195-184A-4BA5-A9F0-9D9DCFA6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7531FF-CD52-4A08-98FF-FCE995C67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0E03D8-D93E-4C6A-82CA-311139A678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F3401A-D679-4D91-A3D6-1BFEC924F8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FD359E-598F-48C1-9919-AA4F9A618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BFA28E-DC05-4A5E-80D0-463820DA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5DF75A-6B30-432D-8069-36B7C6081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3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81EE9-65FE-4FC5-BC37-CD61273F9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DDD91-0236-4B60-926D-72067C18A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BE5D6-2FF5-4D5B-A6B1-82B41B79C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CF9DE8-7C6E-4F4D-8EA8-7259386AE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2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7E4491-788A-4821-9E6E-570A8CE6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B716BC-9E60-4DEA-A07B-80BD02145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D0791B-A499-45CD-8F78-DA9BE7D30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05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88561-81FB-43F0-AE7A-35A362648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3C397-50A4-4C0C-B407-0138AE86A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49911-E1A7-485F-8AB1-60951F9F82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B1B66C-7CBC-4C89-A559-128787994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4D22C-025D-4125-A048-33F23A3A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55B70-97CF-4715-83C6-6ADAF3E23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2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4FC6C-F436-486E-9F5D-CB67FA0E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FC830-4DC3-4C31-8286-900695D144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0CFC38-6DC0-4B24-9B16-723421F654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46571-AE5F-4C6D-A1E8-85F1A45A7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8367C-6D79-4E70-B7B1-590275D59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8B58E-1339-4343-8DE4-B6BFD476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6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B21B23-1BE5-4230-8070-F5D9436C0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53AED6-C2E9-4DA5-B4A7-73250757F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29CA7-A24A-4A68-BC90-765289BA88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8A1B4-6CAD-452C-B2DF-90DB79436B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3B7F6-D911-46CA-9FD0-EBCAED55DA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4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064A0-E636-4F00-ADAA-B8117F0F4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85546" y="1880274"/>
            <a:ext cx="7516003" cy="2384299"/>
          </a:xfrm>
        </p:spPr>
        <p:txBody>
          <a:bodyPr>
            <a:normAutofit fontScale="90000"/>
          </a:bodyPr>
          <a:lstStyle/>
          <a:p>
            <a:r>
              <a:rPr lang="en-US" b="1" dirty="0"/>
              <a:t>Supplemental Figure 4:</a:t>
            </a:r>
            <a:br>
              <a:rPr lang="en-US" b="1" dirty="0"/>
            </a:b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4. Survival curves of experimentally challenged animals by cohort.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 Three-to-five day old CD-1 mouse pups were orally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avaged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with 5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μl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f a preparation containing 1x10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9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FU of wild type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V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olerae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16961 mixed with a 1:1 dilution of pooled day 63 serum from mice intramuscularly immunized with phosphate buffered saline (PBS) or conjugate vaccine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SP:rTTHc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with or without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mmunoadjuvantative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lum.</a:t>
            </a:r>
            <a:br>
              <a:rPr lang="en-US" sz="1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0485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3">
            <a:extLst>
              <a:ext uri="{FF2B5EF4-FFF2-40B4-BE49-F238E27FC236}">
                <a16:creationId xmlns:a16="http://schemas.microsoft.com/office/drawing/2014/main" id="{C2885FCE-204B-4C05-9AC7-B9549D5305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0129" y="549368"/>
            <a:ext cx="2765476" cy="5961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4397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1</TotalTime>
  <Words>78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l Figure 4: Figure S4. Survival curves of experimentally challenged animals by cohort.  Three-to-five day old CD-1 mouse pups were orally gavaged with 50 μl of a preparation containing 1x109 CFU of wild type V. cholerae N16961 mixed with a 1:1 dilution of pooled day 63 serum from mice intramuscularly immunized with phosphate buffered saline (PBS) or conjugate vaccine (OSP:rTTHc) with or without immunoadjuvantative alum.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y, Meagan</dc:creator>
  <cp:lastModifiedBy>Ryan, Edward T.,M.D.</cp:lastModifiedBy>
  <cp:revision>69</cp:revision>
  <cp:lastPrinted>2021-06-03T18:55:09Z</cp:lastPrinted>
  <dcterms:created xsi:type="dcterms:W3CDTF">2020-08-13T18:26:36Z</dcterms:created>
  <dcterms:modified xsi:type="dcterms:W3CDTF">2021-10-19T17:29:19Z</dcterms:modified>
</cp:coreProperties>
</file>